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940"/>
  </p:normalViewPr>
  <p:slideViewPr>
    <p:cSldViewPr snapToGrid="0" snapToObjects="1">
      <p:cViewPr varScale="1">
        <p:scale>
          <a:sx n="115" d="100"/>
          <a:sy n="115" d="100"/>
        </p:scale>
        <p:origin x="47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B3EA06-B750-BA43-A97F-650B896E00F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00BF4F3-27C2-F445-8463-6260A13F03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1CD509-8EC6-E647-9607-18DD8F497C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CBFF0-2430-F247-B610-8473EF13C795}" type="datetimeFigureOut">
              <a:rPr lang="en-US" smtClean="0"/>
              <a:t>5/2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DD6759-FA0E-8B40-B51C-8368348114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7BA9E7-E2BC-B24D-BDAF-32599CD6D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8750C-93EA-CC4C-96AB-7783F7754F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448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50426E-86E5-D64A-8AA1-4C54E5C76C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BC3DA7-3024-FB47-9486-63A89D22F9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260F38-E480-F449-9E53-08017488F4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CBFF0-2430-F247-B610-8473EF13C795}" type="datetimeFigureOut">
              <a:rPr lang="en-US" smtClean="0"/>
              <a:t>5/2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A22288-989F-6B42-96C0-125ED7113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BA2DE8-8DE9-2043-9234-B5D6A4CB3D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8750C-93EA-CC4C-96AB-7783F7754F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891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6D9F9C8-3FDF-F849-A40F-53F45926180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3751C0-3047-554F-8CD6-E16498D477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11905C-4609-C245-AF5B-2B48183A1D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CBFF0-2430-F247-B610-8473EF13C795}" type="datetimeFigureOut">
              <a:rPr lang="en-US" smtClean="0"/>
              <a:t>5/2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344F38-EE85-D748-817C-0E10DFE2F6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CEFD9F-93C2-244C-8A38-85D808D25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8750C-93EA-CC4C-96AB-7783F7754F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0357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C75BB2-CFEC-3D47-B69B-12C2F333E6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E9F8FF-E64A-C04A-886A-DC03D2B4BF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B81F0E-5C9B-6149-9D70-162016F580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CBFF0-2430-F247-B610-8473EF13C795}" type="datetimeFigureOut">
              <a:rPr lang="en-US" smtClean="0"/>
              <a:t>5/2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5D562D-2F5F-D643-8233-65E58F1435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9BEAF9-CADA-7042-98A9-32E35E48D0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8750C-93EA-CC4C-96AB-7783F7754F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6338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D48288-E60E-3349-BB77-06F27FF9F3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A857BA-CCD4-854D-9C51-F8B8FD0F51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03DE07-C444-5449-9C29-CA27D9F813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CBFF0-2430-F247-B610-8473EF13C795}" type="datetimeFigureOut">
              <a:rPr lang="en-US" smtClean="0"/>
              <a:t>5/2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243B7C-FC60-914F-842C-D4CD047E3D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AD16E8-C5BD-F444-8FAC-B5D511376D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8750C-93EA-CC4C-96AB-7783F7754F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553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188504-B396-2E48-BE41-3CBE664FA4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E3B959-84F6-A94B-9305-66F1A29688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506BFD-8123-834B-9818-608FF8BEE8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71B044-D2E7-9E4C-9B98-B77310B1E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CBFF0-2430-F247-B610-8473EF13C795}" type="datetimeFigureOut">
              <a:rPr lang="en-US" smtClean="0"/>
              <a:t>5/29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E828D5-3C2D-F74F-9921-E996AD8668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0610FC-EB93-014C-B113-679903A3EC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8750C-93EA-CC4C-96AB-7783F7754F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4989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D80EA5-C602-464C-BC76-F2AC0B3EFE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29932E-D5F1-8F45-AA5E-38ACC0BE15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098F126-EC4C-8448-8B59-2A9A42BB87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9413CF5-CCBC-CF4A-891E-DB81AEFA56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D428AD9-7E63-0342-9543-98C5DBDF39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A9D7AFC-3213-1345-AA55-A7E144A0D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CBFF0-2430-F247-B610-8473EF13C795}" type="datetimeFigureOut">
              <a:rPr lang="en-US" smtClean="0"/>
              <a:t>5/29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F3CE67E-AEA2-7A41-B693-6CFEB47FD4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AC9F81D-797D-D049-A421-4AF01B6C4D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8750C-93EA-CC4C-96AB-7783F7754F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128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5F911C-C61F-934B-AD61-D6FF244ECB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F9AC950-5241-5E4E-A473-9EBD6E126E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CBFF0-2430-F247-B610-8473EF13C795}" type="datetimeFigureOut">
              <a:rPr lang="en-US" smtClean="0"/>
              <a:t>5/29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855DBE4-FBA3-6544-8376-251BE468ED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A3C9F2F-EAE4-5944-9565-D6C6CC7B49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8750C-93EA-CC4C-96AB-7783F7754F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4105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82A8A7B-CDC1-F543-A695-738FE870D0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CBFF0-2430-F247-B610-8473EF13C795}" type="datetimeFigureOut">
              <a:rPr lang="en-US" smtClean="0"/>
              <a:t>5/29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7B95696-3D37-E048-BDCB-76B495BF4B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EDC0A86-A384-4F41-B4CE-147449A2D1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8750C-93EA-CC4C-96AB-7783F7754F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697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182800-CBD8-C446-8C72-2E7C433CB3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A8837B-23BF-1749-89E0-1F55A933E8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65A1B3A-A63A-D24F-AB02-B1FB542BBF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D2F48F-C820-0946-9A54-2D79B0C18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CBFF0-2430-F247-B610-8473EF13C795}" type="datetimeFigureOut">
              <a:rPr lang="en-US" smtClean="0"/>
              <a:t>5/29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D774C3-E4B7-C94C-AA4D-8EAE29A9A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C6C778-07D0-B24A-A4F2-B991CF4F0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8750C-93EA-CC4C-96AB-7783F7754F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085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5D3E26-28B7-B14D-8FBC-41D230EB4B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59B3557-6773-A64F-BCBA-2BC913C6B8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A644AA9-99D5-2448-94B3-AC8B6643E2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3CB9DC-E035-F34B-9833-25DC9AEFAB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CBFF0-2430-F247-B610-8473EF13C795}" type="datetimeFigureOut">
              <a:rPr lang="en-US" smtClean="0"/>
              <a:t>5/29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D7F61B-3CB5-5841-A714-D05889CD6E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A541A3-A205-DC4F-8109-9F80181E40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8750C-93EA-CC4C-96AB-7783F7754F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43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39F0986-0810-4841-9E82-B49D1FED09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65C7BD-E6A8-9441-8421-CB5AE6C6C0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120C69-F302-E04B-B139-CBEA2A4685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6CBFF0-2430-F247-B610-8473EF13C795}" type="datetimeFigureOut">
              <a:rPr lang="en-US" smtClean="0"/>
              <a:t>5/2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501109-F0A0-DC4F-8E33-A301BD3429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DE2DA0-6E21-E845-8571-2CF5E125DB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58750C-93EA-CC4C-96AB-7783F7754F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47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886BD3DA-D7EA-5649-8AC4-C664001D2D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5426" y="1894447"/>
            <a:ext cx="7480917" cy="40045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C052607-ECDB-104B-A096-3D8759632399}"/>
              </a:ext>
            </a:extLst>
          </p:cNvPr>
          <p:cNvSpPr txBox="1"/>
          <p:nvPr/>
        </p:nvSpPr>
        <p:spPr>
          <a:xfrm>
            <a:off x="1337084" y="1541507"/>
            <a:ext cx="37892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DisGeNet</a:t>
            </a:r>
            <a:r>
              <a:rPr lang="en-US" dirty="0"/>
              <a:t>  Analysi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AC06B21-B651-2E4F-AABC-FA511BC6CAB7}"/>
              </a:ext>
            </a:extLst>
          </p:cNvPr>
          <p:cNvSpPr txBox="1"/>
          <p:nvPr/>
        </p:nvSpPr>
        <p:spPr>
          <a:xfrm>
            <a:off x="947854" y="423746"/>
            <a:ext cx="101087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2. </a:t>
            </a:r>
            <a:r>
              <a:rPr lang="en-US" dirty="0" err="1"/>
              <a:t>Metascape</a:t>
            </a:r>
            <a:r>
              <a:rPr lang="en-US" dirty="0"/>
              <a:t> </a:t>
            </a:r>
            <a:r>
              <a:rPr lang="en-US" dirty="0" err="1"/>
              <a:t>DisGeNet</a:t>
            </a:r>
            <a:r>
              <a:rPr lang="en-US" dirty="0"/>
              <a:t> Analysis for differentially expressed plasma proteome associated with ACLF patients who progress to AKI. </a:t>
            </a:r>
          </a:p>
        </p:txBody>
      </p:sp>
    </p:spTree>
    <p:extLst>
      <p:ext uri="{BB962C8B-B14F-4D97-AF65-F5344CB8AC3E}">
        <p14:creationId xmlns:p14="http://schemas.microsoft.com/office/powerpoint/2010/main" val="10025102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3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agyan Acharya</dc:creator>
  <cp:lastModifiedBy>Pragyan Acharya</cp:lastModifiedBy>
  <cp:revision>3</cp:revision>
  <dcterms:created xsi:type="dcterms:W3CDTF">2022-03-22T07:11:59Z</dcterms:created>
  <dcterms:modified xsi:type="dcterms:W3CDTF">2022-05-29T07:55:46Z</dcterms:modified>
</cp:coreProperties>
</file>